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xlsx" ContentType="application/vnd.openxmlformats-officedocument.spreadsheetml.sheet"/>
  <Default Extension="vml" ContentType="application/vnd.openxmlformats-officedocument.vmlDrawi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3"/>
  </p:handoutMasterIdLst>
  <p:sldIdLst>
    <p:sldId id="261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878" autoAdjust="0"/>
  </p:normalViewPr>
  <p:slideViewPr>
    <p:cSldViewPr snapToGrid="0" snapToObjects="1">
      <p:cViewPr>
        <p:scale>
          <a:sx n="150" d="100"/>
          <a:sy n="150" d="100"/>
        </p:scale>
        <p:origin x="-2328" y="-12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Relationship Id="rId2" Type="http://schemas.openxmlformats.org/officeDocument/2006/relationships/image" Target="../media/image2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74DEAE-028C-B944-B47B-237DF458337B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6EAFF1-BE5A-2945-866C-649ACD1668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62871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6700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316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3221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045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2926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825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71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4093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89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6567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869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856F7-A402-3741-8358-BC9FBEE16651}" type="datetimeFigureOut">
              <a:rPr kumimoji="1" lang="ja-JP" altLang="en-US" smtClean="0"/>
              <a:t>2016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AFDF30-7043-1F45-ACD0-0431FF20E6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336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oleObject" Target="../embeddings/oleObject1.bin"/><Relationship Id="rId5" Type="http://schemas.openxmlformats.org/officeDocument/2006/relationships/package" Target="../embeddings/Microsoft_Excel____1.xlsx"/><Relationship Id="rId6" Type="http://schemas.openxmlformats.org/officeDocument/2006/relationships/image" Target="../media/image1.emf"/><Relationship Id="rId7" Type="http://schemas.openxmlformats.org/officeDocument/2006/relationships/oleObject" Target="../embeddings/oleObject2.bin"/><Relationship Id="rId8" Type="http://schemas.openxmlformats.org/officeDocument/2006/relationships/package" Target="../embeddings/Microsoft_Excel____2.xlsx"/><Relationship Id="rId9" Type="http://schemas.openxmlformats.org/officeDocument/2006/relationships/image" Target="../media/image2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3408" y="4375538"/>
            <a:ext cx="4862906" cy="1083734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1387920" y="4112383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0.25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816171" y="4112383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0.5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196042" y="4112383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1.0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558979" y="4112383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3.0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936228" y="4112382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0.25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360017" y="411238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0.5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712484" y="411238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1.0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4064952" y="411238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3.0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409862" y="4112381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0.25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833651" y="4112381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0.5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186118" y="4112381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1.0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616791" y="4112381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3.0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cxnSp>
        <p:nvCxnSpPr>
          <p:cNvPr id="15" name="直線コネクタ 14"/>
          <p:cNvCxnSpPr/>
          <p:nvPr/>
        </p:nvCxnSpPr>
        <p:spPr>
          <a:xfrm>
            <a:off x="1460509" y="4103224"/>
            <a:ext cx="1352528" cy="2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2989744" y="4101843"/>
            <a:ext cx="1352528" cy="2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4527964" y="4101841"/>
            <a:ext cx="1352528" cy="2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5937393" y="4110308"/>
            <a:ext cx="12750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(µL crude protein)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914918" y="3835923"/>
            <a:ext cx="562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Helvetica"/>
                <a:cs typeface="Helvetica"/>
              </a:rPr>
              <a:t>MDM2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431360" y="3835923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Helvetica"/>
                <a:cs typeface="Helvetica"/>
              </a:rPr>
              <a:t>TRIM6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008097" y="3835923"/>
            <a:ext cx="5409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Helvetica"/>
                <a:cs typeface="Helvetica"/>
              </a:rPr>
              <a:t>RAG1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413558" y="545927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solidFill>
                  <a:srgbClr val="FF0000"/>
                </a:solidFill>
                <a:latin typeface="Helvetica"/>
                <a:cs typeface="Helvetica"/>
              </a:rPr>
              <a:t>1.0</a:t>
            </a:r>
            <a:endParaRPr kumimoji="1" lang="ja-JP" altLang="en-US" sz="1000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810162" y="5460649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6.4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162174" y="5460649"/>
            <a:ext cx="427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11.1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511262" y="5459272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18.1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947979" y="5459961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0.2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310916" y="545927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0.6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683314" y="545927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</a:t>
            </a:r>
            <a:r>
              <a:rPr kumimoji="1" lang="en-US" altLang="ja-JP" sz="1000" b="1" dirty="0" smtClean="0">
                <a:latin typeface="Helvetica"/>
                <a:cs typeface="Helvetica"/>
              </a:rPr>
              <a:t>.6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075421" y="545927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Helvetica"/>
                <a:cs typeface="Helvetica"/>
              </a:rPr>
              <a:t>5.3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454390" y="5459961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0.4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825794" y="545927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3</a:t>
            </a:r>
            <a:r>
              <a:rPr kumimoji="1" lang="en-US" altLang="ja-JP" sz="1000" b="1" dirty="0" smtClean="0">
                <a:latin typeface="Helvetica"/>
                <a:cs typeface="Helvetica"/>
              </a:rPr>
              <a:t>.6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215126" y="5459272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Helvetica"/>
                <a:cs typeface="Helvetica"/>
              </a:rPr>
              <a:t>9.5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581832" y="5459272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Helvetica"/>
                <a:cs typeface="Helvetica"/>
              </a:rPr>
              <a:t>19.2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graphicFrame>
        <p:nvGraphicFramePr>
          <p:cNvPr id="34" name="オブジェクト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6331326"/>
              </p:ext>
            </p:extLst>
          </p:nvPr>
        </p:nvGraphicFramePr>
        <p:xfrm>
          <a:off x="1273175" y="447675"/>
          <a:ext cx="3451225" cy="2684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ワークシート" r:id="rId5" imgW="4102100" imgH="3187700" progId="Excel.Sheet.12">
                  <p:embed/>
                </p:oleObj>
              </mc:Choice>
              <mc:Fallback>
                <p:oleObj name="ワークシート" r:id="rId5" imgW="4102100" imgH="31877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73175" y="447675"/>
                        <a:ext cx="3451225" cy="2684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オブジェクト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2164508"/>
              </p:ext>
            </p:extLst>
          </p:nvPr>
        </p:nvGraphicFramePr>
        <p:xfrm>
          <a:off x="5064358" y="495413"/>
          <a:ext cx="3432175" cy="2638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ワークシート" r:id="rId8" imgW="4076700" imgH="3136900" progId="Excel.Sheet.12">
                  <p:embed/>
                </p:oleObj>
              </mc:Choice>
              <mc:Fallback>
                <p:oleObj name="ワークシート" r:id="rId8" imgW="4076700" imgH="31369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064358" y="495413"/>
                        <a:ext cx="3432175" cy="2638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テキスト ボックス 39"/>
          <p:cNvSpPr txBox="1"/>
          <p:nvPr/>
        </p:nvSpPr>
        <p:spPr>
          <a:xfrm>
            <a:off x="692678" y="257843"/>
            <a:ext cx="505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Helvetica"/>
                <a:cs typeface="Helvetica"/>
              </a:rPr>
              <a:t>(A)</a:t>
            </a:r>
            <a:endParaRPr kumimoji="1" lang="ja-JP" altLang="en-US" b="1" dirty="0">
              <a:latin typeface="Helvetica"/>
              <a:cs typeface="Helvetica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6016091" y="5460649"/>
            <a:ext cx="1582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Helvetica"/>
                <a:cs typeface="Helvetica"/>
              </a:rPr>
              <a:t>Relative band intensity</a:t>
            </a:r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692678" y="3602150"/>
            <a:ext cx="505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Helvetica"/>
                <a:cs typeface="Helvetica"/>
              </a:rPr>
              <a:t>(B)</a:t>
            </a:r>
            <a:endParaRPr kumimoji="1" lang="ja-JP" altLang="en-US" b="1" dirty="0">
              <a:latin typeface="Helvetica"/>
              <a:cs typeface="Helvetica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8255769" y="0"/>
            <a:ext cx="727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2 Fig </a:t>
            </a:r>
            <a:endParaRPr kumimoji="1" lang="ja-JP" altLang="en-US" dirty="0"/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511262" y="3132250"/>
            <a:ext cx="15747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Helvetica"/>
                <a:cs typeface="Helvetica"/>
              </a:rPr>
              <a:t>Crude E3 protein (µl)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6214534" y="3133838"/>
            <a:ext cx="15747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Helvetica"/>
                <a:cs typeface="Helvetica"/>
              </a:rPr>
              <a:t>Crude E3 protein (µl)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 rot="16200000">
            <a:off x="325253" y="1612900"/>
            <a:ext cx="15015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Helvetica"/>
                <a:cs typeface="Helvetica"/>
              </a:rPr>
              <a:t>Luminescent signal 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 rot="16200000">
            <a:off x="4155445" y="1612900"/>
            <a:ext cx="15015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 smtClean="0">
                <a:latin typeface="Helvetica"/>
                <a:cs typeface="Helvetica"/>
              </a:rPr>
              <a:t>Luminescent signal 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9667600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1</TotalTime>
  <Words>59</Words>
  <Application>Microsoft Macintosh PowerPoint</Application>
  <PresentationFormat>画面に合わせる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3" baseType="lpstr">
      <vt:lpstr>ホワイト</vt:lpstr>
      <vt:lpstr>ワークシート</vt:lpstr>
      <vt:lpstr>PowerPoint プレゼンテーション</vt:lpstr>
    </vt:vector>
  </TitlesOfParts>
  <Company>愛媛大学 プロテオサイエンスセンター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橋 宏隆</dc:creator>
  <cp:lastModifiedBy>高橋 宏隆</cp:lastModifiedBy>
  <cp:revision>104</cp:revision>
  <cp:lastPrinted>2016-02-09T01:58:40Z</cp:lastPrinted>
  <dcterms:created xsi:type="dcterms:W3CDTF">2016-01-27T04:47:13Z</dcterms:created>
  <dcterms:modified xsi:type="dcterms:W3CDTF">2016-04-22T07:59:15Z</dcterms:modified>
</cp:coreProperties>
</file>